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officedocument.obfuscatedFont" Extension="odttf"/>
  <Default ContentType="application/vnd.openxmlformats-package.relationships+xml" Extension="rels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9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4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6.xml"/>
  <Override ContentType="application/vnd.openxmlformats-officedocument.presentationml.slide+xml" PartName="/ppt/slides/slide9.xml"/>
  <Override ContentType="application/vnd.openxmlformats-officedocument.presentationml.slide+xml" PartName="/ppt/slides/slide5.xml"/>
  <Override ContentType="application/vnd.openxmlformats-officedocument.presentationml.slide+xml" PartName="/ppt/slides/slide8.xml"/>
  <Override ContentType="application/vnd.openxmlformats-officedocument.presentationml.slide+xml" PartName="/ppt/slides/slide7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  <p:sldId id="262" r:id="rId12"/>
    <p:sldId id="263" r:id="rId13"/>
    <p:sldId id="264" r:id="rId14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GoogleSlidesCustomDataVersion2">
      <go:slidesCustomData xmlns:go="http://customooxmlschemas.google.com/" r:id="rId15" roundtripDataSignature="AMtx7mgK5ryV99iONDpqEkSS+4gfvgePZ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1" Type="http://schemas.openxmlformats.org/officeDocument/2006/relationships/slide" Target="slides/slide6.xml"/><Relationship Id="rId10" Type="http://schemas.openxmlformats.org/officeDocument/2006/relationships/slide" Target="slides/slide5.xml"/><Relationship Id="rId13" Type="http://schemas.openxmlformats.org/officeDocument/2006/relationships/slide" Target="slides/slide8.xml"/><Relationship Id="rId12" Type="http://schemas.openxmlformats.org/officeDocument/2006/relationships/slide" Target="slides/slide7.xml"/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5" Type="http://customschemas.google.com/relationships/presentationmetadata" Target="metadata"/><Relationship Id="rId14" Type="http://schemas.openxmlformats.org/officeDocument/2006/relationships/slide" Target="slides/slide9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-298450" lvl="1" marL="914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-298450" lvl="2" marL="1371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-298450" lvl="3" marL="1828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-298450" lvl="4" marL="22860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-298450" lvl="5" marL="27432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-298450" lvl="6" marL="32004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-298450" lvl="7" marL="36576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-298450" lvl="8" marL="411480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b="0" i="0" sz="11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52" name="Google Shape;52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7" name="Shape 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Google Shape;58;p2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59" name="Google Shape;59;p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4" name="Shape 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Google Shape;65;p3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66" name="Google Shape;66;p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76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4:notes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78" name="Google Shape;78;p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8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p5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90" name="Google Shape;90;p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0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6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02" name="Google Shape;102;p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3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7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15" name="Google Shape;115;p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6" name="Shape 1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Google Shape;127;p8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28" name="Google Shape;128;p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6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Google Shape;137;p9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38" name="Google Shape;138;p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3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2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5" name="Google Shape;45;p2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6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Google Shape;47;p2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  <a:noFill/>
          <a:ln>
            <a:noFill/>
          </a:ln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8" name="Google Shape;48;p2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9" name="Google Shape;49;p2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1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  <a:noFill/>
          <a:ln>
            <a:noFill/>
          </a:ln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3" name="Google Shape;13;p1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4" name="Google Shape;14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3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7" name="Google Shape;17;p13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8" name="Google Shape;18;p1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9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14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21" name="Google Shape;21;p1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2" name="Shape 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Google Shape;23;p1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4" name="Google Shape;24;p1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5" name="Google Shape;25;p1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6" name="Google Shape;26;p1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9" name="Google Shape;29;p1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30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1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  <a:noFill/>
          <a:ln>
            <a:noFill/>
          </a:ln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2" name="Google Shape;32;p1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3" name="Google Shape;33;p1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4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6" name="Google Shape;36;p1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7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t/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9" name="Google Shape;39;p1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  <a:noFill/>
          <a:ln>
            <a:noFill/>
          </a:ln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40" name="Google Shape;40;p1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41" name="Google Shape;41;p1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2" name="Google Shape;42;p1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0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7" name="Google Shape;7;p10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Font typeface="Arial"/>
              <a:buChar char="●"/>
              <a:defRPr b="0" i="0" sz="18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-317500" lvl="1" marL="91440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b="0" i="0" sz="14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-317500" lvl="2" marL="137160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b="0" i="0" sz="14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-317500" lvl="3" marL="182880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b="0" i="0" sz="14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-317500" lvl="4" marL="228600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b="0" i="0" sz="14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-317500" lvl="5" marL="274320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b="0" i="0" sz="14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-317500" lvl="6" marL="320040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●"/>
              <a:defRPr b="0" i="0" sz="14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-317500" lvl="7" marL="365760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○"/>
              <a:defRPr b="0" i="0" sz="14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-317500" lvl="8" marL="411480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Font typeface="Arial"/>
              <a:buChar char="■"/>
              <a:defRPr b="0" i="0" sz="14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8" name="Google Shape;8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indent="0" lvl="0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b="0" i="0" sz="1000" u="none" cap="none" strike="noStrike">
                <a:solidFill>
                  <a:schemeClr val="dk2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4.png"/><Relationship Id="rId4" Type="http://schemas.openxmlformats.org/officeDocument/2006/relationships/hyperlink" Target="https://cellcollective.org/#" TargetMode="External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hyperlink" Target="https://www.youtube.com/watch?v=Zu5_MtsMu2c" TargetMode="External"/><Relationship Id="rId4" Type="http://schemas.openxmlformats.org/officeDocument/2006/relationships/image" Target="../media/image9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8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5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3.pn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6.pn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1.png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2.png"/></Relationships>
</file>

<file path=ppt/slides/_rels/slide9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"/>
          <p:cNvSpPr txBox="1"/>
          <p:nvPr/>
        </p:nvSpPr>
        <p:spPr>
          <a:xfrm>
            <a:off x="44577" y="163150"/>
            <a:ext cx="8635500" cy="581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45720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1" i="0" lang="fr" sz="12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Supplementary Figure 1.</a:t>
            </a:r>
            <a:r>
              <a:rPr b="0" i="0" lang="fr" sz="12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 Cell Collective platform </a:t>
            </a:r>
            <a:endParaRPr b="0" i="0" sz="12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45720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0" i="0" lang="fr" sz="12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A)The link to the Demo of Cell Collective</a:t>
            </a:r>
            <a:endParaRPr b="0" i="0" sz="12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55" name="Google Shape;55;p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354900" y="813925"/>
            <a:ext cx="5901862" cy="3571701"/>
          </a:xfrm>
          <a:prstGeom prst="rect">
            <a:avLst/>
          </a:prstGeom>
          <a:noFill/>
          <a:ln>
            <a:noFill/>
          </a:ln>
        </p:spPr>
      </p:pic>
      <p:sp>
        <p:nvSpPr>
          <p:cNvPr id="56" name="Google Shape;56;p1"/>
          <p:cNvSpPr txBox="1"/>
          <p:nvPr/>
        </p:nvSpPr>
        <p:spPr>
          <a:xfrm>
            <a:off x="1354900" y="4385625"/>
            <a:ext cx="6119100" cy="554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0" i="0" lang="fr" sz="12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creenshot of the interactive demo to build and analyze logical models in Cell Collective. </a:t>
            </a:r>
            <a:r>
              <a:rPr b="0" i="0" lang="fr" sz="1200" u="sng" cap="none" strike="noStrike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4"/>
              </a:rPr>
              <a:t>https://cellcollective.org/#</a:t>
            </a:r>
            <a:r>
              <a:rPr b="0" i="0" lang="fr" sz="12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endParaRPr b="0" i="0" sz="12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60" name="Shape 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Google Shape;61;p2"/>
          <p:cNvSpPr txBox="1"/>
          <p:nvPr/>
        </p:nvSpPr>
        <p:spPr>
          <a:xfrm>
            <a:off x="96601" y="242000"/>
            <a:ext cx="44754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0" i="0" lang="fr" sz="12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B) The link to the YouTube Tutorial of Cell Collective</a:t>
            </a:r>
            <a:endParaRPr b="0" i="0" sz="12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2" name="Google Shape;62;p2"/>
          <p:cNvSpPr txBox="1"/>
          <p:nvPr/>
        </p:nvSpPr>
        <p:spPr>
          <a:xfrm>
            <a:off x="1354900" y="4385625"/>
            <a:ext cx="6119100" cy="554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0" i="0" lang="fr" sz="12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creenshot of the introduction to Cell Collective in YouTube. </a:t>
            </a:r>
            <a:r>
              <a:rPr b="0" i="0" lang="fr" sz="1200" u="sng" cap="none" strike="noStrike">
                <a:solidFill>
                  <a:schemeClr val="hlink"/>
                </a:solidFill>
                <a:latin typeface="Arial"/>
                <a:ea typeface="Arial"/>
                <a:cs typeface="Arial"/>
                <a:sym typeface="Arial"/>
                <a:hlinkClick r:id="rId3"/>
              </a:rPr>
              <a:t>https://www.youtube.com/watch?v=Zu5_MtsMu2c</a:t>
            </a:r>
            <a:r>
              <a:rPr b="0" i="0" lang="fr" sz="12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endParaRPr b="0" i="0" sz="12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63" name="Google Shape;63;p2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1354900" y="692400"/>
            <a:ext cx="5542837" cy="348347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67" name="Shape 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Google Shape;68;p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52375" y="951725"/>
            <a:ext cx="6123574" cy="3611450"/>
          </a:xfrm>
          <a:prstGeom prst="rect">
            <a:avLst/>
          </a:prstGeom>
          <a:noFill/>
          <a:ln>
            <a:noFill/>
          </a:ln>
        </p:spPr>
      </p:pic>
      <p:sp>
        <p:nvSpPr>
          <p:cNvPr id="69" name="Google Shape;69;p3"/>
          <p:cNvSpPr txBox="1"/>
          <p:nvPr/>
        </p:nvSpPr>
        <p:spPr>
          <a:xfrm>
            <a:off x="5769825" y="319880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0" name="Google Shape;70;p3"/>
          <p:cNvSpPr txBox="1"/>
          <p:nvPr/>
        </p:nvSpPr>
        <p:spPr>
          <a:xfrm>
            <a:off x="2032650" y="1456738"/>
            <a:ext cx="1809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1" name="Google Shape;71;p3"/>
          <p:cNvSpPr txBox="1"/>
          <p:nvPr/>
        </p:nvSpPr>
        <p:spPr>
          <a:xfrm>
            <a:off x="1982550" y="25372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2" name="Google Shape;72;p3"/>
          <p:cNvSpPr txBox="1"/>
          <p:nvPr/>
        </p:nvSpPr>
        <p:spPr>
          <a:xfrm>
            <a:off x="2711300" y="321920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3" name="Google Shape;73;p3"/>
          <p:cNvSpPr txBox="1"/>
          <p:nvPr/>
        </p:nvSpPr>
        <p:spPr>
          <a:xfrm>
            <a:off x="2328150" y="14567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4" name="Google Shape;74;p3"/>
          <p:cNvSpPr txBox="1"/>
          <p:nvPr/>
        </p:nvSpPr>
        <p:spPr>
          <a:xfrm>
            <a:off x="6314700" y="1425075"/>
            <a:ext cx="2745300" cy="2108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1-Description and date of the model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2-List of references of the model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3-</a:t>
            </a:r>
            <a:r>
              <a:rPr b="0" i="0" lang="fr" sz="1000" u="none" cap="none" strike="noStrike">
                <a:solidFill>
                  <a:schemeClr val="dk1"/>
                </a:solidFill>
                <a:highlight>
                  <a:schemeClr val="lt1"/>
                </a:highlight>
                <a:latin typeface="Arial"/>
                <a:ea typeface="Arial"/>
                <a:cs typeface="Arial"/>
                <a:sym typeface="Arial"/>
              </a:rPr>
              <a:t>Overview of the model with nodes and interactions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4-</a:t>
            </a:r>
            <a:r>
              <a:rPr b="0" i="0" lang="fr" sz="1000" u="none" cap="none" strike="noStrike">
                <a:solidFill>
                  <a:schemeClr val="dk1"/>
                </a:solidFill>
                <a:highlight>
                  <a:schemeClr val="lt1"/>
                </a:highlight>
                <a:latin typeface="Arial"/>
                <a:ea typeface="Arial"/>
                <a:cs typeface="Arial"/>
                <a:sym typeface="Arial"/>
              </a:rPr>
              <a:t>List of all components in the model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5-Knowledge base: literature related to Acute rejection</a:t>
            </a:r>
            <a:endParaRPr b="0" i="0" sz="13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75" name="Google Shape;75;p3"/>
          <p:cNvSpPr txBox="1"/>
          <p:nvPr/>
        </p:nvSpPr>
        <p:spPr>
          <a:xfrm>
            <a:off x="99952" y="441800"/>
            <a:ext cx="86355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0" i="0" lang="fr" sz="12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C) Example of the Cell Collective environment- Overview panel</a:t>
            </a:r>
            <a:endParaRPr b="0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79" name="Shape 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Google Shape;80;p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99950" y="1259875"/>
            <a:ext cx="5925351" cy="3170701"/>
          </a:xfrm>
          <a:prstGeom prst="rect">
            <a:avLst/>
          </a:prstGeom>
          <a:noFill/>
          <a:ln>
            <a:noFill/>
          </a:ln>
        </p:spPr>
      </p:pic>
      <p:sp>
        <p:nvSpPr>
          <p:cNvPr id="81" name="Google Shape;81;p4"/>
          <p:cNvSpPr txBox="1"/>
          <p:nvPr/>
        </p:nvSpPr>
        <p:spPr>
          <a:xfrm>
            <a:off x="6140925" y="1217650"/>
            <a:ext cx="2745300" cy="3170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1-Overview of the model with nodes and interactions.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2-Internal components (green indicated the number of positive regulators and red, the number of negative regulators)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3-List of external components (search bar for quick screen)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4-Regulatory mechanism: example of Eosinophils (green indicates the positive regulators and red indicates negative regulators)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5-Knowledge base: literature related to Eosinophils </a:t>
            </a:r>
            <a:endParaRPr b="0" i="0" sz="13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2" name="Google Shape;82;p4"/>
          <p:cNvSpPr txBox="1"/>
          <p:nvPr/>
        </p:nvSpPr>
        <p:spPr>
          <a:xfrm>
            <a:off x="5648175" y="29374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3" name="Google Shape;83;p4"/>
          <p:cNvSpPr txBox="1"/>
          <p:nvPr/>
        </p:nvSpPr>
        <p:spPr>
          <a:xfrm>
            <a:off x="99952" y="441800"/>
            <a:ext cx="86355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0" i="0" lang="fr" sz="12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D) Example of the Cell Collective environment- Model panel</a:t>
            </a:r>
            <a:endParaRPr b="0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4" name="Google Shape;84;p4"/>
          <p:cNvSpPr txBox="1"/>
          <p:nvPr/>
        </p:nvSpPr>
        <p:spPr>
          <a:xfrm>
            <a:off x="147275" y="2537238"/>
            <a:ext cx="1809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5" name="Google Shape;85;p4"/>
          <p:cNvSpPr txBox="1"/>
          <p:nvPr/>
        </p:nvSpPr>
        <p:spPr>
          <a:xfrm>
            <a:off x="3417325" y="1658575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6" name="Google Shape;86;p4"/>
          <p:cNvSpPr txBox="1"/>
          <p:nvPr/>
        </p:nvSpPr>
        <p:spPr>
          <a:xfrm>
            <a:off x="4779125" y="14567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7" name="Google Shape;87;p4"/>
          <p:cNvSpPr txBox="1"/>
          <p:nvPr/>
        </p:nvSpPr>
        <p:spPr>
          <a:xfrm>
            <a:off x="3614025" y="325940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Google Shape;92;p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01675" y="1143600"/>
            <a:ext cx="6041174" cy="3237125"/>
          </a:xfrm>
          <a:prstGeom prst="rect">
            <a:avLst/>
          </a:prstGeom>
          <a:noFill/>
          <a:ln>
            <a:noFill/>
          </a:ln>
        </p:spPr>
      </p:pic>
      <p:sp>
        <p:nvSpPr>
          <p:cNvPr id="93" name="Google Shape;93;p5"/>
          <p:cNvSpPr txBox="1"/>
          <p:nvPr/>
        </p:nvSpPr>
        <p:spPr>
          <a:xfrm>
            <a:off x="6142850" y="918250"/>
            <a:ext cx="2954400" cy="3701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1-To simulate the model: the panel includes speed, steps, stop and start buttons. 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2-To ch</a:t>
            </a:r>
            <a:r>
              <a:rPr b="0" i="0" lang="fr" sz="1000" u="none" cap="none" strike="noStrike">
                <a:solidFill>
                  <a:srgbClr val="0000FF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o</a:t>
            </a: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ose the external component and percentage of activity as inputs : example of IAV, with 100% activity.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3-To ch</a:t>
            </a:r>
            <a:r>
              <a:rPr b="0" i="0" lang="fr" sz="1000" u="none" cap="none" strike="noStrike">
                <a:solidFill>
                  <a:srgbClr val="0000FF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o</a:t>
            </a: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ose internal components to visualize on the graph (oeil button), to activate or inhibit (pill button). Example provided is dendritic cells (DC-APC) and NK dim cells.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4-Activity network in real time showing active and inactive nodes. The green indicates active and red, inactive ones. 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5-Simulation graph for visualization of the simulation: example of DC-APC and NK dim  under IAV environment, legends provided on the top right corner. </a:t>
            </a:r>
            <a:endParaRPr b="0" i="0" sz="13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4" name="Google Shape;94;p5"/>
          <p:cNvSpPr txBox="1"/>
          <p:nvPr/>
        </p:nvSpPr>
        <p:spPr>
          <a:xfrm>
            <a:off x="1195400" y="1628775"/>
            <a:ext cx="1809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5" name="Google Shape;95;p5"/>
          <p:cNvSpPr txBox="1"/>
          <p:nvPr/>
        </p:nvSpPr>
        <p:spPr>
          <a:xfrm>
            <a:off x="1192425" y="22669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6" name="Google Shape;96;p5"/>
          <p:cNvSpPr txBox="1"/>
          <p:nvPr/>
        </p:nvSpPr>
        <p:spPr>
          <a:xfrm>
            <a:off x="1192425" y="32956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7" name="Google Shape;97;p5"/>
          <p:cNvSpPr txBox="1"/>
          <p:nvPr/>
        </p:nvSpPr>
        <p:spPr>
          <a:xfrm>
            <a:off x="2383050" y="13763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8" name="Google Shape;98;p5"/>
          <p:cNvSpPr txBox="1"/>
          <p:nvPr/>
        </p:nvSpPr>
        <p:spPr>
          <a:xfrm>
            <a:off x="5031000" y="259260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9" name="Google Shape;99;p5"/>
          <p:cNvSpPr txBox="1"/>
          <p:nvPr/>
        </p:nvSpPr>
        <p:spPr>
          <a:xfrm>
            <a:off x="53001" y="457675"/>
            <a:ext cx="75540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0" i="0" lang="fr" sz="12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E) Example of the Cell Collective environment- Real-time panel simulations</a:t>
            </a:r>
            <a:endParaRPr b="0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3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Google Shape;104;p6" title="Screenshot from 2025-06-24 11-57-02.png"/>
          <p:cNvPicPr preferRelativeResize="0"/>
          <p:nvPr/>
        </p:nvPicPr>
        <p:blipFill rotWithShape="1">
          <a:blip r:embed="rId3">
            <a:alphaModFix/>
          </a:blip>
          <a:srcRect b="610" l="0" r="0" t="-610"/>
          <a:stretch/>
        </p:blipFill>
        <p:spPr>
          <a:xfrm>
            <a:off x="85375" y="1127688"/>
            <a:ext cx="6093802" cy="3040527"/>
          </a:xfrm>
          <a:prstGeom prst="rect">
            <a:avLst/>
          </a:prstGeom>
          <a:noFill/>
          <a:ln>
            <a:noFill/>
          </a:ln>
        </p:spPr>
      </p:pic>
      <p:sp>
        <p:nvSpPr>
          <p:cNvPr id="105" name="Google Shape;105;p6"/>
          <p:cNvSpPr txBox="1"/>
          <p:nvPr/>
        </p:nvSpPr>
        <p:spPr>
          <a:xfrm>
            <a:off x="6235675" y="922500"/>
            <a:ext cx="2903400" cy="4233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1-To create a file for new experiment 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2-To ch</a:t>
            </a:r>
            <a:r>
              <a:rPr b="0" i="0" lang="fr" sz="1000" u="none" cap="none" strike="noStrike">
                <a:solidFill>
                  <a:srgbClr val="0000FF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o</a:t>
            </a: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ose experimental settings: name of the file, number of simulation, environment, initial state, range of simulation. Data can be downloaded using the arrow button. 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3-To choose external component and the desired activity level: example of IAV activity and resting state range 0-100% while all others are at 0.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4-To choose one or multiple internal components to activate or inhibit using the pill button.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5-Activity relationship Graph for visualization: example of IAV external environment (IAV_ESC) and NK Dim/Bright. 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6-In the graph components, choose what to display in the graph for x and y axis (X= IAV_ESC, Y= NK Dim/Bright)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6" name="Google Shape;106;p6"/>
          <p:cNvSpPr txBox="1"/>
          <p:nvPr/>
        </p:nvSpPr>
        <p:spPr>
          <a:xfrm>
            <a:off x="900125" y="1676400"/>
            <a:ext cx="1809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7" name="Google Shape;107;p6"/>
          <p:cNvSpPr txBox="1"/>
          <p:nvPr/>
        </p:nvSpPr>
        <p:spPr>
          <a:xfrm>
            <a:off x="916200" y="32764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8" name="Google Shape;108;p6"/>
          <p:cNvSpPr txBox="1"/>
          <p:nvPr/>
        </p:nvSpPr>
        <p:spPr>
          <a:xfrm>
            <a:off x="2021100" y="135240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9" name="Google Shape;109;p6"/>
          <p:cNvSpPr txBox="1"/>
          <p:nvPr/>
        </p:nvSpPr>
        <p:spPr>
          <a:xfrm>
            <a:off x="1992525" y="34099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0" name="Google Shape;110;p6"/>
          <p:cNvSpPr txBox="1"/>
          <p:nvPr/>
        </p:nvSpPr>
        <p:spPr>
          <a:xfrm>
            <a:off x="3554625" y="1592475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1" name="Google Shape;111;p6"/>
          <p:cNvSpPr txBox="1"/>
          <p:nvPr/>
        </p:nvSpPr>
        <p:spPr>
          <a:xfrm>
            <a:off x="5869200" y="144960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2" name="Google Shape;112;p6"/>
          <p:cNvSpPr txBox="1"/>
          <p:nvPr/>
        </p:nvSpPr>
        <p:spPr>
          <a:xfrm>
            <a:off x="85376" y="325225"/>
            <a:ext cx="79539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0" i="0" lang="fr" sz="12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F) Example of the Cell Collective environment- Dose response analysis panel</a:t>
            </a:r>
            <a:endParaRPr b="0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6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Google Shape;117;p7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0" y="1036251"/>
            <a:ext cx="6235676" cy="2937124"/>
          </a:xfrm>
          <a:prstGeom prst="rect">
            <a:avLst/>
          </a:prstGeom>
          <a:noFill/>
          <a:ln>
            <a:noFill/>
          </a:ln>
        </p:spPr>
      </p:pic>
      <p:sp>
        <p:nvSpPr>
          <p:cNvPr id="118" name="Google Shape;118;p7"/>
          <p:cNvSpPr txBox="1"/>
          <p:nvPr/>
        </p:nvSpPr>
        <p:spPr>
          <a:xfrm>
            <a:off x="6235675" y="922500"/>
            <a:ext cx="2903400" cy="4233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1-To create a file for new experiment 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2-To ch</a:t>
            </a:r>
            <a:r>
              <a:rPr b="0" i="0" lang="fr" sz="1000" u="none" cap="none" strike="noStrike">
                <a:solidFill>
                  <a:srgbClr val="0000FF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o</a:t>
            </a: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ose experimental settings: name of the file, number of simulation, environment, initial state, range of simulation. Data can be downloaded using the arrow button. 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3-To choose external component and the desired activity level: example of IAV activity and resting state range 0-100% while all others are at 0.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4-To choose one or multiple internal components to activate or inhibit using the pill button.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5-Activity relationship Graph for visualization: example of IAV external environment (IAV_ESC) and IFNb and IL1b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6-In the graph components, choose what to display in the graph for x and y axis (X= IAV_ESC, Y= IFNb/IL1b)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9" name="Google Shape;119;p7"/>
          <p:cNvSpPr txBox="1"/>
          <p:nvPr/>
        </p:nvSpPr>
        <p:spPr>
          <a:xfrm>
            <a:off x="900125" y="1676400"/>
            <a:ext cx="1809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0" name="Google Shape;120;p7"/>
          <p:cNvSpPr txBox="1"/>
          <p:nvPr/>
        </p:nvSpPr>
        <p:spPr>
          <a:xfrm>
            <a:off x="916200" y="32764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1" name="Google Shape;121;p7"/>
          <p:cNvSpPr txBox="1"/>
          <p:nvPr/>
        </p:nvSpPr>
        <p:spPr>
          <a:xfrm>
            <a:off x="2021100" y="135240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2" name="Google Shape;122;p7"/>
          <p:cNvSpPr txBox="1"/>
          <p:nvPr/>
        </p:nvSpPr>
        <p:spPr>
          <a:xfrm>
            <a:off x="1992525" y="34099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3" name="Google Shape;123;p7"/>
          <p:cNvSpPr txBox="1"/>
          <p:nvPr/>
        </p:nvSpPr>
        <p:spPr>
          <a:xfrm>
            <a:off x="3554625" y="1592475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5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4" name="Google Shape;124;p7"/>
          <p:cNvSpPr txBox="1"/>
          <p:nvPr/>
        </p:nvSpPr>
        <p:spPr>
          <a:xfrm>
            <a:off x="5869200" y="144960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6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5" name="Google Shape;125;p7"/>
          <p:cNvSpPr txBox="1"/>
          <p:nvPr/>
        </p:nvSpPr>
        <p:spPr>
          <a:xfrm>
            <a:off x="85376" y="325225"/>
            <a:ext cx="79539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0" i="0" lang="fr" sz="12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G) Example of the Cell Collective environment- Dose response analysis panel</a:t>
            </a:r>
            <a:endParaRPr b="0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9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Google Shape;130;p8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221900" y="1280850"/>
            <a:ext cx="5953626" cy="3353824"/>
          </a:xfrm>
          <a:prstGeom prst="rect">
            <a:avLst/>
          </a:prstGeom>
          <a:noFill/>
          <a:ln>
            <a:noFill/>
          </a:ln>
        </p:spPr>
      </p:pic>
      <p:sp>
        <p:nvSpPr>
          <p:cNvPr id="131" name="Google Shape;131;p8"/>
          <p:cNvSpPr txBox="1"/>
          <p:nvPr/>
        </p:nvSpPr>
        <p:spPr>
          <a:xfrm>
            <a:off x="6240925" y="1838475"/>
            <a:ext cx="2745300" cy="1931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1-List of the internal and external components of the model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2-Knowledge base: description, regulators and references are provided (example of DC-APC). 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t/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3-Reference Graph: overview of the model. Example of DC connection to other components highlighted in blue.  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2" name="Google Shape;132;p8"/>
          <p:cNvSpPr txBox="1"/>
          <p:nvPr/>
        </p:nvSpPr>
        <p:spPr>
          <a:xfrm>
            <a:off x="129652" y="515225"/>
            <a:ext cx="86157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0" i="0" lang="fr" sz="12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H) Example of the Cell Collective environment- Knowledge Base</a:t>
            </a:r>
            <a:endParaRPr b="0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3" name="Google Shape;133;p8"/>
          <p:cNvSpPr txBox="1"/>
          <p:nvPr/>
        </p:nvSpPr>
        <p:spPr>
          <a:xfrm>
            <a:off x="836300" y="15856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4" name="Google Shape;134;p8"/>
          <p:cNvSpPr txBox="1"/>
          <p:nvPr/>
        </p:nvSpPr>
        <p:spPr>
          <a:xfrm>
            <a:off x="3259350" y="1757250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5" name="Google Shape;135;p8"/>
          <p:cNvSpPr txBox="1"/>
          <p:nvPr/>
        </p:nvSpPr>
        <p:spPr>
          <a:xfrm>
            <a:off x="4995375" y="1590675"/>
            <a:ext cx="2811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b="0" i="0" lang="fr" sz="1400" u="none" cap="none" strike="noStrik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endParaRPr b="0" i="0" sz="1400" u="none" cap="none" strike="noStrik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9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p9"/>
          <p:cNvSpPr txBox="1"/>
          <p:nvPr/>
        </p:nvSpPr>
        <p:spPr>
          <a:xfrm>
            <a:off x="103577" y="298025"/>
            <a:ext cx="86157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b="0" i="0" lang="fr" sz="12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I) Example of the Cell Collective environment- Download SBML-qual file</a:t>
            </a:r>
            <a:endParaRPr b="0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1" name="Google Shape;141;p9"/>
          <p:cNvSpPr txBox="1"/>
          <p:nvPr/>
        </p:nvSpPr>
        <p:spPr>
          <a:xfrm>
            <a:off x="2333725" y="3454875"/>
            <a:ext cx="3389400" cy="869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b="0" i="0" lang="fr" sz="1000" u="none" cap="none" strike="noStrike">
                <a:solidFill>
                  <a:schemeClr val="dk1"/>
                </a:solidFill>
                <a:highlight>
                  <a:srgbClr val="FFFFFF"/>
                </a:highlight>
                <a:latin typeface="Arial"/>
                <a:ea typeface="Arial"/>
                <a:cs typeface="Arial"/>
                <a:sym typeface="Arial"/>
              </a:rPr>
              <a:t>Screenshot of the Cell Collective platform that allows the users to download the DC model’s SBML-qual, Boolean expressions, truth tables, interaction matrix, GML, and knowledge base files.</a:t>
            </a:r>
            <a:endParaRPr b="0" i="0" sz="1000" u="none" cap="none" strike="noStrike">
              <a:solidFill>
                <a:schemeClr val="dk1"/>
              </a:solidFill>
              <a:highlight>
                <a:srgbClr val="FFFFFF"/>
              </a:highlight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42" name="Google Shape;142;p9" title="Screenshot from 2025-06-30 15-56-14.png"/>
          <p:cNvPicPr preferRelativeResize="0"/>
          <p:nvPr/>
        </p:nvPicPr>
        <p:blipFill rotWithShape="1">
          <a:blip r:embed="rId3">
            <a:alphaModFix/>
          </a:blip>
          <a:srcRect b="47395" l="0" r="65139" t="11423"/>
          <a:stretch/>
        </p:blipFill>
        <p:spPr>
          <a:xfrm>
            <a:off x="2208663" y="938400"/>
            <a:ext cx="3639524" cy="244317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